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lt-L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1" d="100"/>
          <a:sy n="81" d="100"/>
        </p:scale>
        <p:origin x="91" y="16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8001E0-8F64-C9C1-BDA5-33AD321A6B3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lt-LT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21DF33A-4BFB-2DC3-DDF6-ABC192609F2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lt-L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122572-AC00-035C-DCAC-4AB71B03BA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76181D-A646-4D6F-8E0E-2E7A439E11AF}" type="datetimeFigureOut">
              <a:rPr lang="lt-LT" smtClean="0"/>
              <a:t>2023-12-23</a:t>
            </a:fld>
            <a:endParaRPr lang="lt-L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2CB1C9-C159-9F3C-1228-D7BB146EE7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t-L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581E8D9-E58C-939B-1C46-F26E8E4F04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F2123D-0D4B-4240-A3E0-BDFC44EACD29}" type="slidenum">
              <a:rPr lang="lt-LT" smtClean="0"/>
              <a:t>‹#›</a:t>
            </a:fld>
            <a:endParaRPr lang="lt-LT"/>
          </a:p>
        </p:txBody>
      </p:sp>
    </p:spTree>
    <p:extLst>
      <p:ext uri="{BB962C8B-B14F-4D97-AF65-F5344CB8AC3E}">
        <p14:creationId xmlns:p14="http://schemas.microsoft.com/office/powerpoint/2010/main" val="23017543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44B74B-7A75-6777-C2B2-50E3D8ECDC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lt-LT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96C1DBB-EF8B-D5EE-49FF-33ACDDE7065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lt-L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E3A57C-EF4A-1015-EC28-180C242023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76181D-A646-4D6F-8E0E-2E7A439E11AF}" type="datetimeFigureOut">
              <a:rPr lang="lt-LT" smtClean="0"/>
              <a:t>2023-12-23</a:t>
            </a:fld>
            <a:endParaRPr lang="lt-L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C443FB-3397-0D9E-1E8C-1229448073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t-L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4A66B5-DFB5-D724-CC64-3815857DA0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F2123D-0D4B-4240-A3E0-BDFC44EACD29}" type="slidenum">
              <a:rPr lang="lt-LT" smtClean="0"/>
              <a:t>‹#›</a:t>
            </a:fld>
            <a:endParaRPr lang="lt-LT"/>
          </a:p>
        </p:txBody>
      </p:sp>
    </p:spTree>
    <p:extLst>
      <p:ext uri="{BB962C8B-B14F-4D97-AF65-F5344CB8AC3E}">
        <p14:creationId xmlns:p14="http://schemas.microsoft.com/office/powerpoint/2010/main" val="14803876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DBB4545-6F36-45ED-7B75-5C4E3363C12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lt-LT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813F07A-16EC-00EB-CE1B-E4BA622D879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lt-L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2DE144-8C1F-52CA-D721-D9AEF83280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76181D-A646-4D6F-8E0E-2E7A439E11AF}" type="datetimeFigureOut">
              <a:rPr lang="lt-LT" smtClean="0"/>
              <a:t>2023-12-23</a:t>
            </a:fld>
            <a:endParaRPr lang="lt-L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84E284-BB8F-CC14-9B22-29390B3F82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t-L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2F9503-D6CF-8391-4204-7F2354580B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F2123D-0D4B-4240-A3E0-BDFC44EACD29}" type="slidenum">
              <a:rPr lang="lt-LT" smtClean="0"/>
              <a:t>‹#›</a:t>
            </a:fld>
            <a:endParaRPr lang="lt-LT"/>
          </a:p>
        </p:txBody>
      </p:sp>
    </p:spTree>
    <p:extLst>
      <p:ext uri="{BB962C8B-B14F-4D97-AF65-F5344CB8AC3E}">
        <p14:creationId xmlns:p14="http://schemas.microsoft.com/office/powerpoint/2010/main" val="20685116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5D151C-E996-0FD6-F757-CB0575D40F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lt-L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88139CD-B319-09F6-0A20-4BA3C6C2E24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lt-L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E9D736-048D-6949-07C0-0862B65DD4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76181D-A646-4D6F-8E0E-2E7A439E11AF}" type="datetimeFigureOut">
              <a:rPr lang="lt-LT" smtClean="0"/>
              <a:t>2023-12-23</a:t>
            </a:fld>
            <a:endParaRPr lang="lt-L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C449F8-0F48-A2E7-52FF-568B9472CE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t-L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2A0677-B052-08EF-CC73-0769D483D8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F2123D-0D4B-4240-A3E0-BDFC44EACD29}" type="slidenum">
              <a:rPr lang="lt-LT" smtClean="0"/>
              <a:t>‹#›</a:t>
            </a:fld>
            <a:endParaRPr lang="lt-LT"/>
          </a:p>
        </p:txBody>
      </p:sp>
    </p:spTree>
    <p:extLst>
      <p:ext uri="{BB962C8B-B14F-4D97-AF65-F5344CB8AC3E}">
        <p14:creationId xmlns:p14="http://schemas.microsoft.com/office/powerpoint/2010/main" val="36472976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549520-C6B2-B3A6-80EC-FBB581E333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lt-L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F2ACCCE-6236-10D3-361B-BDE1443086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78C16C-0678-E7E3-87F4-C0EA33DF59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76181D-A646-4D6F-8E0E-2E7A439E11AF}" type="datetimeFigureOut">
              <a:rPr lang="lt-LT" smtClean="0"/>
              <a:t>2023-12-23</a:t>
            </a:fld>
            <a:endParaRPr lang="lt-L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F927A9-7FE7-876B-E49F-42476D08BF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t-L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64E058-07A0-6F62-1B08-9E19B34605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F2123D-0D4B-4240-A3E0-BDFC44EACD29}" type="slidenum">
              <a:rPr lang="lt-LT" smtClean="0"/>
              <a:t>‹#›</a:t>
            </a:fld>
            <a:endParaRPr lang="lt-LT"/>
          </a:p>
        </p:txBody>
      </p:sp>
    </p:spTree>
    <p:extLst>
      <p:ext uri="{BB962C8B-B14F-4D97-AF65-F5344CB8AC3E}">
        <p14:creationId xmlns:p14="http://schemas.microsoft.com/office/powerpoint/2010/main" val="22908324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A73CBD-FB89-31AF-18AE-065B8AB103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lt-L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0501593-C049-224F-1D72-189F0F2C29D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lt-LT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FE67AB5-5525-6B0C-A22F-88F9BFB9C4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lt-LT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B2BF343-F825-852A-643E-EBC82BA7F4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76181D-A646-4D6F-8E0E-2E7A439E11AF}" type="datetimeFigureOut">
              <a:rPr lang="lt-LT" smtClean="0"/>
              <a:t>2023-12-23</a:t>
            </a:fld>
            <a:endParaRPr lang="lt-L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F2D632D-B067-097D-B1B4-91A9B381F0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t-L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0A18947-17F8-A1D7-A843-87118A7DB7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F2123D-0D4B-4240-A3E0-BDFC44EACD29}" type="slidenum">
              <a:rPr lang="lt-LT" smtClean="0"/>
              <a:t>‹#›</a:t>
            </a:fld>
            <a:endParaRPr lang="lt-LT"/>
          </a:p>
        </p:txBody>
      </p:sp>
    </p:spTree>
    <p:extLst>
      <p:ext uri="{BB962C8B-B14F-4D97-AF65-F5344CB8AC3E}">
        <p14:creationId xmlns:p14="http://schemas.microsoft.com/office/powerpoint/2010/main" val="17254200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833A69-919B-AD3E-A05E-5E5FF57A21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lt-L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9CD678F-B30A-AAA7-624D-0F2ABA6952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A73F6BE-710C-51F9-5693-DB5FA293D8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lt-LT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E66972D-CAB9-E5D2-1464-9F085A4E145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17744B4-FA3D-252B-D91E-87163C3D9C7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lt-LT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97FD0E3-4DED-ED91-0A9E-5064808A02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76181D-A646-4D6F-8E0E-2E7A439E11AF}" type="datetimeFigureOut">
              <a:rPr lang="lt-LT" smtClean="0"/>
              <a:t>2023-12-23</a:t>
            </a:fld>
            <a:endParaRPr lang="lt-LT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A8840F9-4762-A2A4-6EA6-F34C888478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t-LT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5A27617-3D99-D112-D32A-50BE522D46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F2123D-0D4B-4240-A3E0-BDFC44EACD29}" type="slidenum">
              <a:rPr lang="lt-LT" smtClean="0"/>
              <a:t>‹#›</a:t>
            </a:fld>
            <a:endParaRPr lang="lt-LT"/>
          </a:p>
        </p:txBody>
      </p:sp>
    </p:spTree>
    <p:extLst>
      <p:ext uri="{BB962C8B-B14F-4D97-AF65-F5344CB8AC3E}">
        <p14:creationId xmlns:p14="http://schemas.microsoft.com/office/powerpoint/2010/main" val="35868358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C76DE0-4CB1-1CB6-3049-2B0515C1A2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lt-LT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40FEB2D-9E73-CEFB-F571-87347CB51F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76181D-A646-4D6F-8E0E-2E7A439E11AF}" type="datetimeFigureOut">
              <a:rPr lang="lt-LT" smtClean="0"/>
              <a:t>2023-12-23</a:t>
            </a:fld>
            <a:endParaRPr lang="lt-LT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E7D046D-5281-E1F1-16D1-DD15C4AAEE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t-LT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06DC1A7-AB4A-A058-5749-794E23AEC1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F2123D-0D4B-4240-A3E0-BDFC44EACD29}" type="slidenum">
              <a:rPr lang="lt-LT" smtClean="0"/>
              <a:t>‹#›</a:t>
            </a:fld>
            <a:endParaRPr lang="lt-LT"/>
          </a:p>
        </p:txBody>
      </p:sp>
    </p:spTree>
    <p:extLst>
      <p:ext uri="{BB962C8B-B14F-4D97-AF65-F5344CB8AC3E}">
        <p14:creationId xmlns:p14="http://schemas.microsoft.com/office/powerpoint/2010/main" val="10558399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6022EC4-950B-0D60-44C3-79F94B014E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76181D-A646-4D6F-8E0E-2E7A439E11AF}" type="datetimeFigureOut">
              <a:rPr lang="lt-LT" smtClean="0"/>
              <a:t>2023-12-23</a:t>
            </a:fld>
            <a:endParaRPr lang="lt-LT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F443578-B51D-7086-94ED-2C26F0A559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t-LT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EE5540D-9AD4-C064-B39D-84FF0E07B2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F2123D-0D4B-4240-A3E0-BDFC44EACD29}" type="slidenum">
              <a:rPr lang="lt-LT" smtClean="0"/>
              <a:t>‹#›</a:t>
            </a:fld>
            <a:endParaRPr lang="lt-LT"/>
          </a:p>
        </p:txBody>
      </p:sp>
    </p:spTree>
    <p:extLst>
      <p:ext uri="{BB962C8B-B14F-4D97-AF65-F5344CB8AC3E}">
        <p14:creationId xmlns:p14="http://schemas.microsoft.com/office/powerpoint/2010/main" val="8196313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2AA194-79C1-6F6D-CE9C-E75ED32FDC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lt-L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76B6C07-EE6D-98DE-6BF3-A0FA43A302F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lt-LT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068DBE0-7386-5070-AD0E-F89A3C61610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5BAE652-DE7B-CD96-B4A4-12113E857F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76181D-A646-4D6F-8E0E-2E7A439E11AF}" type="datetimeFigureOut">
              <a:rPr lang="lt-LT" smtClean="0"/>
              <a:t>2023-12-23</a:t>
            </a:fld>
            <a:endParaRPr lang="lt-L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BF8AC9A-62C2-4149-9264-13F17400DB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t-L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79EAF0B-2492-A777-935D-F0C7804367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F2123D-0D4B-4240-A3E0-BDFC44EACD29}" type="slidenum">
              <a:rPr lang="lt-LT" smtClean="0"/>
              <a:t>‹#›</a:t>
            </a:fld>
            <a:endParaRPr lang="lt-LT"/>
          </a:p>
        </p:txBody>
      </p:sp>
    </p:spTree>
    <p:extLst>
      <p:ext uri="{BB962C8B-B14F-4D97-AF65-F5344CB8AC3E}">
        <p14:creationId xmlns:p14="http://schemas.microsoft.com/office/powerpoint/2010/main" val="1235796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7C43A4-F8D0-BA0E-88F1-20A128E4B4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lt-LT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32F031F-39D4-7181-E57E-91738B05A46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lt-LT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9B33CD5-25D6-CD4D-87B2-EAF7F06BBFF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2C054F4-45D9-AB29-0670-7E0F01B224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76181D-A646-4D6F-8E0E-2E7A439E11AF}" type="datetimeFigureOut">
              <a:rPr lang="lt-LT" smtClean="0"/>
              <a:t>2023-12-23</a:t>
            </a:fld>
            <a:endParaRPr lang="lt-L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A88F6AC-B69E-501E-62F5-B64F1F8B22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t-L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0ED1A4C-619F-486A-E552-EC95DB7298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F2123D-0D4B-4240-A3E0-BDFC44EACD29}" type="slidenum">
              <a:rPr lang="lt-LT" smtClean="0"/>
              <a:t>‹#›</a:t>
            </a:fld>
            <a:endParaRPr lang="lt-LT"/>
          </a:p>
        </p:txBody>
      </p:sp>
    </p:spTree>
    <p:extLst>
      <p:ext uri="{BB962C8B-B14F-4D97-AF65-F5344CB8AC3E}">
        <p14:creationId xmlns:p14="http://schemas.microsoft.com/office/powerpoint/2010/main" val="10348285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80FD3F0-C00E-EC9B-9A20-17D23A7852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lt-L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A07401F-37D3-F84E-10F0-0640200470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lt-L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D63B23-3F54-6DFA-5CB7-B049AB2D82B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76181D-A646-4D6F-8E0E-2E7A439E11AF}" type="datetimeFigureOut">
              <a:rPr lang="lt-LT" smtClean="0"/>
              <a:t>2023-12-23</a:t>
            </a:fld>
            <a:endParaRPr lang="lt-L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E5DC2C-03A3-55B0-E382-03F8E49C271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lt-L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580990-C95D-C14C-061A-6E6C6ED10EE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F2123D-0D4B-4240-A3E0-BDFC44EACD29}" type="slidenum">
              <a:rPr lang="lt-LT" smtClean="0"/>
              <a:t>‹#›</a:t>
            </a:fld>
            <a:endParaRPr lang="lt-LT"/>
          </a:p>
        </p:txBody>
      </p:sp>
    </p:spTree>
    <p:extLst>
      <p:ext uri="{BB962C8B-B14F-4D97-AF65-F5344CB8AC3E}">
        <p14:creationId xmlns:p14="http://schemas.microsoft.com/office/powerpoint/2010/main" val="12490567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lt-L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a diagram of a health system">
            <a:extLst>
              <a:ext uri="{FF2B5EF4-FFF2-40B4-BE49-F238E27FC236}">
                <a16:creationId xmlns:a16="http://schemas.microsoft.com/office/drawing/2014/main" id="{0D89FABE-C3A5-3F16-0F22-12E68583F82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4350" y="1862137"/>
            <a:ext cx="3543300" cy="313372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223D215-E92B-9E73-F5F5-B53976C32723}"/>
              </a:ext>
            </a:extLst>
          </p:cNvPr>
          <p:cNvSpPr txBox="1"/>
          <p:nvPr/>
        </p:nvSpPr>
        <p:spPr>
          <a:xfrm>
            <a:off x="813062" y="193843"/>
            <a:ext cx="11008149" cy="966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. Directed acyclic graph illustrating the hypothesized associations between caries experience (exposure) and periodontal parameters (outcome) with confounders. Oral health-related behavior included sugar-containing diet, tooth brushing frequency, use of interdental care products, last dental visit, smoking.</a:t>
            </a:r>
            <a:endParaRPr lang="lt-LT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66015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9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na Stangvaltaite-Mouhat</dc:creator>
  <cp:lastModifiedBy>Lina Stangvaltaite-Mouhat</cp:lastModifiedBy>
  <cp:revision>1</cp:revision>
  <dcterms:created xsi:type="dcterms:W3CDTF">2023-12-23T21:13:41Z</dcterms:created>
  <dcterms:modified xsi:type="dcterms:W3CDTF">2023-12-23T21:15:4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06768ce0-ceaf-4778-8ab1-e65d26fe9939_Enabled">
    <vt:lpwstr>true</vt:lpwstr>
  </property>
  <property fmtid="{D5CDD505-2E9C-101B-9397-08002B2CF9AE}" pid="3" name="MSIP_Label_06768ce0-ceaf-4778-8ab1-e65d26fe9939_SetDate">
    <vt:lpwstr>2023-12-23T21:15:24Z</vt:lpwstr>
  </property>
  <property fmtid="{D5CDD505-2E9C-101B-9397-08002B2CF9AE}" pid="4" name="MSIP_Label_06768ce0-ceaf-4778-8ab1-e65d26fe9939_Method">
    <vt:lpwstr>Standard</vt:lpwstr>
  </property>
  <property fmtid="{D5CDD505-2E9C-101B-9397-08002B2CF9AE}" pid="5" name="MSIP_Label_06768ce0-ceaf-4778-8ab1-e65d26fe9939_Name">
    <vt:lpwstr>Begrenset - PROD</vt:lpwstr>
  </property>
  <property fmtid="{D5CDD505-2E9C-101B-9397-08002B2CF9AE}" pid="6" name="MSIP_Label_06768ce0-ceaf-4778-8ab1-e65d26fe9939_SiteId">
    <vt:lpwstr>3d50ddd4-00a1-4ab7-9788-decf14a8728f</vt:lpwstr>
  </property>
  <property fmtid="{D5CDD505-2E9C-101B-9397-08002B2CF9AE}" pid="7" name="MSIP_Label_06768ce0-ceaf-4778-8ab1-e65d26fe9939_ActionId">
    <vt:lpwstr>f5117cd6-1af9-4dc1-beeb-b2e349f706d0</vt:lpwstr>
  </property>
  <property fmtid="{D5CDD505-2E9C-101B-9397-08002B2CF9AE}" pid="8" name="MSIP_Label_06768ce0-ceaf-4778-8ab1-e65d26fe9939_ContentBits">
    <vt:lpwstr>0</vt:lpwstr>
  </property>
</Properties>
</file>